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57" r:id="rId2"/>
    <p:sldId id="263" r:id="rId3"/>
    <p:sldId id="261" r:id="rId4"/>
    <p:sldId id="262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57" d="100"/>
          <a:sy n="57" d="100"/>
        </p:scale>
        <p:origin x="81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image" Target="../media/image2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EE686C4-1855-4C86-AA36-AC28A86CF11B}" type="datetimeFigureOut">
              <a:rPr lang="zh-CN" altLang="en-US" smtClean="0"/>
              <a:t>2022/12/2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3AEE52-F3BC-4957-B49B-C9D2C2BE30E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56042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62AC8-6172-43CB-B77F-781342121166}" type="datetimeFigureOut">
              <a:rPr lang="zh-CN" altLang="en-US" smtClean="0"/>
              <a:t>2022/12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5543E-B9C7-4970-86D9-3AA059D971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25213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62AC8-6172-43CB-B77F-781342121166}" type="datetimeFigureOut">
              <a:rPr lang="zh-CN" altLang="en-US" smtClean="0"/>
              <a:t>2022/12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5543E-B9C7-4970-86D9-3AA059D971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1530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62AC8-6172-43CB-B77F-781342121166}" type="datetimeFigureOut">
              <a:rPr lang="zh-CN" altLang="en-US" smtClean="0"/>
              <a:t>2022/12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5543E-B9C7-4970-86D9-3AA059D971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85132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62AC8-6172-43CB-B77F-781342121166}" type="datetimeFigureOut">
              <a:rPr lang="zh-CN" altLang="en-US" smtClean="0"/>
              <a:t>2022/12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5543E-B9C7-4970-86D9-3AA059D971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36037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62AC8-6172-43CB-B77F-781342121166}" type="datetimeFigureOut">
              <a:rPr lang="zh-CN" altLang="en-US" smtClean="0"/>
              <a:t>2022/12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5543E-B9C7-4970-86D9-3AA059D971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15335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62AC8-6172-43CB-B77F-781342121166}" type="datetimeFigureOut">
              <a:rPr lang="zh-CN" altLang="en-US" smtClean="0"/>
              <a:t>2022/12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5543E-B9C7-4970-86D9-3AA059D971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2923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62AC8-6172-43CB-B77F-781342121166}" type="datetimeFigureOut">
              <a:rPr lang="zh-CN" altLang="en-US" smtClean="0"/>
              <a:t>2022/12/2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5543E-B9C7-4970-86D9-3AA059D971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14556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62AC8-6172-43CB-B77F-781342121166}" type="datetimeFigureOut">
              <a:rPr lang="zh-CN" altLang="en-US" smtClean="0"/>
              <a:t>2022/12/2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5543E-B9C7-4970-86D9-3AA059D971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52282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62AC8-6172-43CB-B77F-781342121166}" type="datetimeFigureOut">
              <a:rPr lang="zh-CN" altLang="en-US" smtClean="0"/>
              <a:t>2022/12/2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5543E-B9C7-4970-86D9-3AA059D971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392912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62AC8-6172-43CB-B77F-781342121166}" type="datetimeFigureOut">
              <a:rPr lang="zh-CN" altLang="en-US" smtClean="0"/>
              <a:t>2022/12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5543E-B9C7-4970-86D9-3AA059D971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3679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A62AC8-6172-43CB-B77F-781342121166}" type="datetimeFigureOut">
              <a:rPr lang="zh-CN" altLang="en-US" smtClean="0"/>
              <a:t>2022/12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5543E-B9C7-4970-86D9-3AA059D971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273450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A62AC8-6172-43CB-B77F-781342121166}" type="datetimeFigureOut">
              <a:rPr lang="zh-CN" altLang="en-US" smtClean="0"/>
              <a:t>2022/12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95543E-B9C7-4970-86D9-3AA059D971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7918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3.emf"/><Relationship Id="rId5" Type="http://schemas.openxmlformats.org/officeDocument/2006/relationships/oleObject" Target="../embeddings/oleObject3.bin"/><Relationship Id="rId4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jpg"/><Relationship Id="rId3" Type="http://schemas.openxmlformats.org/officeDocument/2006/relationships/oleObject" Target="../embeddings/oleObject4.bin"/><Relationship Id="rId7" Type="http://schemas.openxmlformats.org/officeDocument/2006/relationships/image" Target="../media/image5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3.vml"/><Relationship Id="rId6" Type="http://schemas.openxmlformats.org/officeDocument/2006/relationships/oleObject" Target="../embeddings/oleObject5.bin"/><Relationship Id="rId11" Type="http://schemas.openxmlformats.org/officeDocument/2006/relationships/image" Target="../media/image9.jpg"/><Relationship Id="rId5" Type="http://schemas.openxmlformats.org/officeDocument/2006/relationships/image" Target="../media/image7.jpg"/><Relationship Id="rId10" Type="http://schemas.openxmlformats.org/officeDocument/2006/relationships/image" Target="../media/image6.emf"/><Relationship Id="rId4" Type="http://schemas.openxmlformats.org/officeDocument/2006/relationships/image" Target="../media/image4.emf"/><Relationship Id="rId9" Type="http://schemas.openxmlformats.org/officeDocument/2006/relationships/oleObject" Target="../embeddings/oleObject6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"/><Relationship Id="rId2" Type="http://schemas.openxmlformats.org/officeDocument/2006/relationships/image" Target="../media/image10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对象 3">
            <a:extLst>
              <a:ext uri="{FF2B5EF4-FFF2-40B4-BE49-F238E27FC236}">
                <a16:creationId xmlns:a16="http://schemas.microsoft.com/office/drawing/2014/main" id="{732A6789-2B4E-4BA1-82AE-C4D3D9448D27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192338" y="858838"/>
          <a:ext cx="4848225" cy="30654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2" name="Prism 5" r:id="rId3" imgW="4123914" imgH="2606381" progId="Prism5.Document">
                  <p:embed/>
                </p:oleObj>
              </mc:Choice>
              <mc:Fallback>
                <p:oleObj name="Prism 5" r:id="rId3" imgW="4123914" imgH="2606381" progId="Prism5.Document">
                  <p:embed/>
                  <p:pic>
                    <p:nvPicPr>
                      <p:cNvPr id="4" name="对象 3">
                        <a:extLst>
                          <a:ext uri="{FF2B5EF4-FFF2-40B4-BE49-F238E27FC236}">
                            <a16:creationId xmlns:a16="http://schemas.microsoft.com/office/drawing/2014/main" id="{732A6789-2B4E-4BA1-82AE-C4D3D9448D2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192338" y="858838"/>
                        <a:ext cx="4848225" cy="30654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矩形 4">
            <a:extLst>
              <a:ext uri="{FF2B5EF4-FFF2-40B4-BE49-F238E27FC236}">
                <a16:creationId xmlns:a16="http://schemas.microsoft.com/office/drawing/2014/main" id="{086D0117-4AC3-4480-8F3A-425B9169AA61}"/>
              </a:ext>
            </a:extLst>
          </p:cNvPr>
          <p:cNvSpPr/>
          <p:nvPr/>
        </p:nvSpPr>
        <p:spPr>
          <a:xfrm>
            <a:off x="4190879" y="3843696"/>
            <a:ext cx="2384172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L001(</a:t>
            </a:r>
            <a:r>
              <a:rPr lang="el-GR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)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386BCBCB-EF1F-4825-ADF0-9A975452616B}"/>
              </a:ext>
            </a:extLst>
          </p:cNvPr>
          <p:cNvCxnSpPr>
            <a:cxnSpLocks/>
          </p:cNvCxnSpPr>
          <p:nvPr/>
        </p:nvCxnSpPr>
        <p:spPr>
          <a:xfrm>
            <a:off x="3280875" y="3826651"/>
            <a:ext cx="306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文本框 6">
            <a:extLst>
              <a:ext uri="{FF2B5EF4-FFF2-40B4-BE49-F238E27FC236}">
                <a16:creationId xmlns:a16="http://schemas.microsoft.com/office/drawing/2014/main" id="{1DE8CCDA-38E5-AB53-87A5-E15A69342C27}"/>
              </a:ext>
            </a:extLst>
          </p:cNvPr>
          <p:cNvSpPr txBox="1"/>
          <p:nvPr/>
        </p:nvSpPr>
        <p:spPr>
          <a:xfrm>
            <a:off x="143539" y="4448561"/>
            <a:ext cx="8856921" cy="7045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1.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KL001 showed no cytotoxicity to B16F10 cells. MTT assay was performed after treatment with KL001 for 48 hours. Data are expressed as the </a:t>
            </a:r>
            <a:r>
              <a:rPr lang="en-US" altLang="zh-CN" sz="1400" kern="100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ean±SD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(n=3). </a:t>
            </a:r>
            <a:endParaRPr lang="zh-CN" altLang="zh-CN" sz="14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122555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对象 22">
            <a:extLst>
              <a:ext uri="{FF2B5EF4-FFF2-40B4-BE49-F238E27FC236}">
                <a16:creationId xmlns:a16="http://schemas.microsoft.com/office/drawing/2014/main" id="{C67E803B-FF31-4B5B-8981-D4AB827F2FE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80324157"/>
              </p:ext>
            </p:extLst>
          </p:nvPr>
        </p:nvGraphicFramePr>
        <p:xfrm>
          <a:off x="1060106" y="1048215"/>
          <a:ext cx="3389231" cy="30373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48" name="Prism 8" r:id="rId3" imgW="2588656" imgH="2321224" progId="Prism8.Document">
                  <p:embed/>
                </p:oleObj>
              </mc:Choice>
              <mc:Fallback>
                <p:oleObj name="Prism 8" r:id="rId3" imgW="2588656" imgH="2321224" progId="Prism8.Document">
                  <p:embed/>
                  <p:pic>
                    <p:nvPicPr>
                      <p:cNvPr id="73" name="对象 22">
                        <a:extLst>
                          <a:ext uri="{FF2B5EF4-FFF2-40B4-BE49-F238E27FC236}">
                            <a16:creationId xmlns:a16="http://schemas.microsoft.com/office/drawing/2014/main" id="{B090450C-F32D-4145-BE23-0DF7DD2E274F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060106" y="1048215"/>
                        <a:ext cx="3389231" cy="3037326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文本框 4">
            <a:extLst>
              <a:ext uri="{FF2B5EF4-FFF2-40B4-BE49-F238E27FC236}">
                <a16:creationId xmlns:a16="http://schemas.microsoft.com/office/drawing/2014/main" id="{871E0779-9937-48CE-9FC6-BAC885976784}"/>
              </a:ext>
            </a:extLst>
          </p:cNvPr>
          <p:cNvSpPr txBox="1"/>
          <p:nvPr/>
        </p:nvSpPr>
        <p:spPr>
          <a:xfrm>
            <a:off x="826388" y="901241"/>
            <a:ext cx="46743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BE39AD57-6D6F-4A8D-89D5-F15A707AE626}"/>
              </a:ext>
            </a:extLst>
          </p:cNvPr>
          <p:cNvSpPr/>
          <p:nvPr/>
        </p:nvSpPr>
        <p:spPr>
          <a:xfrm>
            <a:off x="2061379" y="3965105"/>
            <a:ext cx="125053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siRNA CTL 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F5709617-CCBC-4399-8970-17A18B614226}"/>
              </a:ext>
            </a:extLst>
          </p:cNvPr>
          <p:cNvSpPr/>
          <p:nvPr/>
        </p:nvSpPr>
        <p:spPr>
          <a:xfrm>
            <a:off x="3062652" y="3958146"/>
            <a:ext cx="182158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siRNA CRY1 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8" name="对象 22">
            <a:extLst>
              <a:ext uri="{FF2B5EF4-FFF2-40B4-BE49-F238E27FC236}">
                <a16:creationId xmlns:a16="http://schemas.microsoft.com/office/drawing/2014/main" id="{385789DF-85CA-4CB0-ABDE-B7BE04163CC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13804512"/>
              </p:ext>
            </p:extLst>
          </p:nvPr>
        </p:nvGraphicFramePr>
        <p:xfrm>
          <a:off x="4683055" y="1041256"/>
          <a:ext cx="3389231" cy="30373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49" name="Prism 8" r:id="rId5" imgW="2588656" imgH="2321224" progId="Prism8.Document">
                  <p:embed/>
                </p:oleObj>
              </mc:Choice>
              <mc:Fallback>
                <p:oleObj name="Prism 8" r:id="rId5" imgW="2588656" imgH="2321224" progId="Prism8.Document">
                  <p:embed/>
                  <p:pic>
                    <p:nvPicPr>
                      <p:cNvPr id="4" name="对象 22">
                        <a:extLst>
                          <a:ext uri="{FF2B5EF4-FFF2-40B4-BE49-F238E27FC236}">
                            <a16:creationId xmlns:a16="http://schemas.microsoft.com/office/drawing/2014/main" id="{C67E803B-FF31-4B5B-8981-D4AB827F2FE2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683055" y="1041256"/>
                        <a:ext cx="3389231" cy="3037326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文本框 8">
            <a:extLst>
              <a:ext uri="{FF2B5EF4-FFF2-40B4-BE49-F238E27FC236}">
                <a16:creationId xmlns:a16="http://schemas.microsoft.com/office/drawing/2014/main" id="{4C762F97-BEE8-40B3-AECE-721D49698DDF}"/>
              </a:ext>
            </a:extLst>
          </p:cNvPr>
          <p:cNvSpPr txBox="1"/>
          <p:nvPr/>
        </p:nvSpPr>
        <p:spPr>
          <a:xfrm>
            <a:off x="4449337" y="894282"/>
            <a:ext cx="46743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 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D7350401-539B-4134-985A-B3011361F6CB}"/>
              </a:ext>
            </a:extLst>
          </p:cNvPr>
          <p:cNvSpPr/>
          <p:nvPr/>
        </p:nvSpPr>
        <p:spPr>
          <a:xfrm>
            <a:off x="5684328" y="3958146"/>
            <a:ext cx="125053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siRNA CTL 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矩形 10">
            <a:extLst>
              <a:ext uri="{FF2B5EF4-FFF2-40B4-BE49-F238E27FC236}">
                <a16:creationId xmlns:a16="http://schemas.microsoft.com/office/drawing/2014/main" id="{BAE14E16-5CFA-4655-9F8C-5444A2AE2C7B}"/>
              </a:ext>
            </a:extLst>
          </p:cNvPr>
          <p:cNvSpPr/>
          <p:nvPr/>
        </p:nvSpPr>
        <p:spPr>
          <a:xfrm>
            <a:off x="6685601" y="3951187"/>
            <a:ext cx="182158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siRNA CRY2 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E2408931-632A-4239-9166-B24A015CE336}"/>
              </a:ext>
            </a:extLst>
          </p:cNvPr>
          <p:cNvSpPr txBox="1"/>
          <p:nvPr/>
        </p:nvSpPr>
        <p:spPr>
          <a:xfrm>
            <a:off x="624469" y="4279841"/>
            <a:ext cx="8519532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siRNA CRY1 (or siRNA CRY2)-mediated knockdown of CRY1 (or CRY2) in </a:t>
            </a:r>
          </a:p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B16F10 cells. B16F10 cells were transfected with  8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M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RY1 (or CRY2) -siRNA indicated for 24 hours. Cells transfected with siRNA CTL were used as controls. Quantitative real-time RT-PCR was performed to quantify the extent to which endogenous CRY1 (or CRY2)  was knocked down. Data are mean ± SD from three independent experiments. ***P&lt;0.001 compared to scramble siRNA CTL.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529329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A9F0C22E-C8F1-4435-A87B-9BC3D30D09C3}"/>
              </a:ext>
            </a:extLst>
          </p:cNvPr>
          <p:cNvSpPr txBox="1"/>
          <p:nvPr/>
        </p:nvSpPr>
        <p:spPr>
          <a:xfrm>
            <a:off x="2725601" y="554800"/>
            <a:ext cx="8494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+) ACTH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对象 4">
            <a:extLst>
              <a:ext uri="{FF2B5EF4-FFF2-40B4-BE49-F238E27FC236}">
                <a16:creationId xmlns:a16="http://schemas.microsoft.com/office/drawing/2014/main" id="{CAA82B4A-F1A3-437F-9C13-5B9024D4F0E5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259603" y="418190"/>
          <a:ext cx="3121025" cy="2108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34" name="Prism 8" r:id="rId3" imgW="3706157" imgH="2572897" progId="Prism8.Document">
                  <p:embed/>
                </p:oleObj>
              </mc:Choice>
              <mc:Fallback>
                <p:oleObj name="Prism 8" r:id="rId3" imgW="3706157" imgH="2572897" progId="Prism8.Document">
                  <p:embed/>
                  <p:pic>
                    <p:nvPicPr>
                      <p:cNvPr id="5" name="对象 4">
                        <a:extLst>
                          <a:ext uri="{FF2B5EF4-FFF2-40B4-BE49-F238E27FC236}">
                            <a16:creationId xmlns:a16="http://schemas.microsoft.com/office/drawing/2014/main" id="{CAA82B4A-F1A3-437F-9C13-5B9024D4F0E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259603" y="418190"/>
                        <a:ext cx="3121025" cy="2108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6" name="图片 5">
            <a:extLst>
              <a:ext uri="{FF2B5EF4-FFF2-40B4-BE49-F238E27FC236}">
                <a16:creationId xmlns:a16="http://schemas.microsoft.com/office/drawing/2014/main" id="{E343448D-BF3C-460B-846A-82D8EBA794D5}"/>
              </a:ext>
            </a:extLst>
          </p:cNvPr>
          <p:cNvPicPr preferRelativeResize="0"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29883" y="2312141"/>
            <a:ext cx="2007219" cy="374130"/>
          </a:xfrm>
          <a:prstGeom prst="rect">
            <a:avLst/>
          </a:prstGeom>
        </p:spPr>
      </p:pic>
      <p:sp>
        <p:nvSpPr>
          <p:cNvPr id="7" name="矩形 6">
            <a:extLst>
              <a:ext uri="{FF2B5EF4-FFF2-40B4-BE49-F238E27FC236}">
                <a16:creationId xmlns:a16="http://schemas.microsoft.com/office/drawing/2014/main" id="{7CD36D3D-A745-4D52-AA93-A58F1A859899}"/>
              </a:ext>
            </a:extLst>
          </p:cNvPr>
          <p:cNvSpPr/>
          <p:nvPr/>
        </p:nvSpPr>
        <p:spPr>
          <a:xfrm>
            <a:off x="1159728" y="2741029"/>
            <a:ext cx="319245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KL001(</a:t>
            </a:r>
            <a:r>
              <a:rPr lang="el-GR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)       -           5          10           20 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" name="组合 7">
            <a:extLst>
              <a:ext uri="{FF2B5EF4-FFF2-40B4-BE49-F238E27FC236}">
                <a16:creationId xmlns:a16="http://schemas.microsoft.com/office/drawing/2014/main" id="{7B2619CE-C9BC-4A27-978E-3935F0103091}"/>
              </a:ext>
            </a:extLst>
          </p:cNvPr>
          <p:cNvGrpSpPr/>
          <p:nvPr/>
        </p:nvGrpSpPr>
        <p:grpSpPr>
          <a:xfrm>
            <a:off x="4973329" y="438032"/>
            <a:ext cx="3184525" cy="2267207"/>
            <a:chOff x="446062" y="3977589"/>
            <a:chExt cx="1884269" cy="1427724"/>
          </a:xfrm>
        </p:grpSpPr>
        <p:graphicFrame>
          <p:nvGraphicFramePr>
            <p:cNvPr id="9" name="对象 8">
              <a:extLst>
                <a:ext uri="{FF2B5EF4-FFF2-40B4-BE49-F238E27FC236}">
                  <a16:creationId xmlns:a16="http://schemas.microsoft.com/office/drawing/2014/main" id="{E1F7BCB4-5045-4F5C-8EE7-3ACB0BDFF3C3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446062" y="3977589"/>
            <a:ext cx="1884269" cy="13455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135" name="Prism 8" r:id="rId6" imgW="3706157" imgH="2572897" progId="Prism8.Document">
                    <p:embed/>
                  </p:oleObj>
                </mc:Choice>
                <mc:Fallback>
                  <p:oleObj name="Prism 8" r:id="rId6" imgW="3706157" imgH="2572897" progId="Prism8.Document">
                    <p:embed/>
                    <p:pic>
                      <p:nvPicPr>
                        <p:cNvPr id="9" name="对象 8">
                          <a:extLst>
                            <a:ext uri="{FF2B5EF4-FFF2-40B4-BE49-F238E27FC236}">
                              <a16:creationId xmlns:a16="http://schemas.microsoft.com/office/drawing/2014/main" id="{E1F7BCB4-5045-4F5C-8EE7-3ACB0BDFF3C3}"/>
                            </a:ext>
                          </a:extLst>
                        </p:cNvPr>
                        <p:cNvPicPr preferRelativeResize="0"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446062" y="3977589"/>
                          <a:ext cx="1884269" cy="13455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10" name="图片 9">
              <a:extLst>
                <a:ext uri="{FF2B5EF4-FFF2-40B4-BE49-F238E27FC236}">
                  <a16:creationId xmlns:a16="http://schemas.microsoft.com/office/drawing/2014/main" id="{C501E35E-DE9C-4D96-B48C-7AAA33A69F8B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31523" y="5180058"/>
              <a:ext cx="1255687" cy="225255"/>
            </a:xfrm>
            <a:prstGeom prst="rect">
              <a:avLst/>
            </a:prstGeom>
          </p:spPr>
        </p:pic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9E30ED52-8B6E-442F-8514-189E5D61A88B}"/>
                </a:ext>
              </a:extLst>
            </p:cNvPr>
            <p:cNvSpPr txBox="1"/>
            <p:nvPr/>
          </p:nvSpPr>
          <p:spPr>
            <a:xfrm>
              <a:off x="1322951" y="4058121"/>
              <a:ext cx="688189" cy="174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+) FSK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aphicFrame>
        <p:nvGraphicFramePr>
          <p:cNvPr id="12" name="对象 11">
            <a:extLst>
              <a:ext uri="{FF2B5EF4-FFF2-40B4-BE49-F238E27FC236}">
                <a16:creationId xmlns:a16="http://schemas.microsoft.com/office/drawing/2014/main" id="{568B8728-B842-4F77-8C78-5A147D1042F4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337953" y="3032009"/>
          <a:ext cx="3073400" cy="21351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36" name="Prism 8" r:id="rId9" imgW="3706157" imgH="2572897" progId="Prism8.Document">
                  <p:embed/>
                </p:oleObj>
              </mc:Choice>
              <mc:Fallback>
                <p:oleObj name="Prism 8" r:id="rId9" imgW="3706157" imgH="2572897" progId="Prism8.Document">
                  <p:embed/>
                  <p:pic>
                    <p:nvPicPr>
                      <p:cNvPr id="12" name="对象 11">
                        <a:extLst>
                          <a:ext uri="{FF2B5EF4-FFF2-40B4-BE49-F238E27FC236}">
                            <a16:creationId xmlns:a16="http://schemas.microsoft.com/office/drawing/2014/main" id="{568B8728-B842-4F77-8C78-5A147D1042F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337953" y="3032009"/>
                        <a:ext cx="3073400" cy="21351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文本框 12">
            <a:extLst>
              <a:ext uri="{FF2B5EF4-FFF2-40B4-BE49-F238E27FC236}">
                <a16:creationId xmlns:a16="http://schemas.microsoft.com/office/drawing/2014/main" id="{7F2BDF68-AAE1-458B-941B-61EC19B0EC7B}"/>
              </a:ext>
            </a:extLst>
          </p:cNvPr>
          <p:cNvSpPr txBox="1"/>
          <p:nvPr/>
        </p:nvSpPr>
        <p:spPr>
          <a:xfrm>
            <a:off x="2681069" y="3191890"/>
            <a:ext cx="8322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+) IBMX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5D8B6E62-B414-42C4-BF83-9BA4FC7627E1}"/>
              </a:ext>
            </a:extLst>
          </p:cNvPr>
          <p:cNvSpPr/>
          <p:nvPr/>
        </p:nvSpPr>
        <p:spPr>
          <a:xfrm>
            <a:off x="1146977" y="5353021"/>
            <a:ext cx="306818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KL001(</a:t>
            </a:r>
            <a:r>
              <a:rPr lang="el-GR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)     -             5            10          20 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5" name="图片 14" descr="杯子里有饮料&#10;&#10;描述已自动生成">
            <a:extLst>
              <a:ext uri="{FF2B5EF4-FFF2-40B4-BE49-F238E27FC236}">
                <a16:creationId xmlns:a16="http://schemas.microsoft.com/office/drawing/2014/main" id="{35C496AF-CB24-4357-A3B6-D713E57D2621}"/>
              </a:ext>
            </a:extLst>
          </p:cNvPr>
          <p:cNvPicPr preferRelativeResize="0">
            <a:picLocks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51808" y="4957528"/>
            <a:ext cx="2085656" cy="364364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DF000FC6-2FF5-4E87-9DA2-3C8C81E24F0C}"/>
              </a:ext>
            </a:extLst>
          </p:cNvPr>
          <p:cNvSpPr txBox="1"/>
          <p:nvPr/>
        </p:nvSpPr>
        <p:spPr>
          <a:xfrm>
            <a:off x="1075708" y="227363"/>
            <a:ext cx="3720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B389656E-2A0F-465D-9AC6-BEC9C478555E}"/>
              </a:ext>
            </a:extLst>
          </p:cNvPr>
          <p:cNvSpPr/>
          <p:nvPr/>
        </p:nvSpPr>
        <p:spPr>
          <a:xfrm>
            <a:off x="4872168" y="2750658"/>
            <a:ext cx="371598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KL001(</a:t>
            </a:r>
            <a:r>
              <a:rPr lang="el-GR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)     -             5           10           20 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D2714733-346C-4F14-861B-23B11C18AE34}"/>
              </a:ext>
            </a:extLst>
          </p:cNvPr>
          <p:cNvSpPr txBox="1"/>
          <p:nvPr/>
        </p:nvSpPr>
        <p:spPr>
          <a:xfrm>
            <a:off x="4600526" y="248913"/>
            <a:ext cx="3722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 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EDDAA6B5-67B1-443D-82EA-0EDBBA6E150F}"/>
              </a:ext>
            </a:extLst>
          </p:cNvPr>
          <p:cNvSpPr txBox="1"/>
          <p:nvPr/>
        </p:nvSpPr>
        <p:spPr>
          <a:xfrm>
            <a:off x="1075708" y="3232667"/>
            <a:ext cx="4475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B1CC8644-94A1-4847-9746-68FA16237D5B}"/>
              </a:ext>
            </a:extLst>
          </p:cNvPr>
          <p:cNvSpPr txBox="1"/>
          <p:nvPr/>
        </p:nvSpPr>
        <p:spPr>
          <a:xfrm>
            <a:off x="490447" y="5765708"/>
            <a:ext cx="8220158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L001 visibly reduced ACTH-, FSK- or IBMX- induced melanogenesis. B16F10 cells were treated with 100nM ACTH, 10μM FSK or 100μM IBMX in presence or absence of KL001 for 48 h and melanin contents were measured as described in methods.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6051311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黑暗中的灯光&#10;&#10;描述已自动生成">
            <a:extLst>
              <a:ext uri="{FF2B5EF4-FFF2-40B4-BE49-F238E27FC236}">
                <a16:creationId xmlns:a16="http://schemas.microsoft.com/office/drawing/2014/main" id="{6E5A9139-D4E8-4ED6-8529-76C43468C539}"/>
              </a:ext>
            </a:extLst>
          </p:cNvPr>
          <p:cNvPicPr preferRelativeResize="0"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5283" y="1895706"/>
            <a:ext cx="2340000" cy="23400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8F79E968-CEF5-4E35-BBA8-8A63A19028E2}"/>
              </a:ext>
            </a:extLst>
          </p:cNvPr>
          <p:cNvPicPr preferRelativeResize="0"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4578" y="1895706"/>
            <a:ext cx="2340000" cy="2340000"/>
          </a:xfrm>
          <a:prstGeom prst="rect">
            <a:avLst/>
          </a:prstGeom>
        </p:spPr>
      </p:pic>
      <p:pic>
        <p:nvPicPr>
          <p:cNvPr id="11" name="图片 10" descr="夜晚天空中有许多星星&#10;&#10;描述已自动生成">
            <a:extLst>
              <a:ext uri="{FF2B5EF4-FFF2-40B4-BE49-F238E27FC236}">
                <a16:creationId xmlns:a16="http://schemas.microsoft.com/office/drawing/2014/main" id="{8F98EA43-611B-4CC8-AC47-8D55E5868EF9}"/>
              </a:ext>
            </a:extLst>
          </p:cNvPr>
          <p:cNvPicPr preferRelativeResize="0"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82722" y="1895706"/>
            <a:ext cx="2340000" cy="2340000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5F1D246E-3D20-4F8E-886A-E79EF593F13C}"/>
              </a:ext>
            </a:extLst>
          </p:cNvPr>
          <p:cNvSpPr txBox="1"/>
          <p:nvPr/>
        </p:nvSpPr>
        <p:spPr>
          <a:xfrm>
            <a:off x="1794917" y="1557152"/>
            <a:ext cx="70073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ne</a:t>
            </a:r>
            <a:endParaRPr lang="zh-CN" altLang="en-US" sz="1600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D659A73D-AB70-4F92-9821-F84C7B42DA7A}"/>
              </a:ext>
            </a:extLst>
          </p:cNvPr>
          <p:cNvSpPr txBox="1"/>
          <p:nvPr/>
        </p:nvSpPr>
        <p:spPr>
          <a:xfrm>
            <a:off x="4257512" y="1557152"/>
            <a:ext cx="1342626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l-GR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MSH</a:t>
            </a:r>
            <a:endParaRPr lang="zh-CN" altLang="en-US" sz="1600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E492746B-BAD0-4983-9941-35F07DDA236D}"/>
              </a:ext>
            </a:extLst>
          </p:cNvPr>
          <p:cNvSpPr txBox="1"/>
          <p:nvPr/>
        </p:nvSpPr>
        <p:spPr>
          <a:xfrm>
            <a:off x="6287365" y="1557152"/>
            <a:ext cx="214927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l-GR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MSH+KL001</a:t>
            </a:r>
            <a:endParaRPr lang="zh-CN" altLang="en-US" sz="1600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BD376AAE-A937-4301-85A8-A99A340DE43E}"/>
              </a:ext>
            </a:extLst>
          </p:cNvPr>
          <p:cNvSpPr txBox="1"/>
          <p:nvPr/>
        </p:nvSpPr>
        <p:spPr>
          <a:xfrm rot="16200000">
            <a:off x="87333" y="2704949"/>
            <a:ext cx="1198756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CREB</a:t>
            </a:r>
            <a:endParaRPr lang="zh-CN" altLang="en-US" sz="1600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5A802626-229A-44E9-8234-303127BAC903}"/>
              </a:ext>
            </a:extLst>
          </p:cNvPr>
          <p:cNvSpPr txBox="1"/>
          <p:nvPr/>
        </p:nvSpPr>
        <p:spPr>
          <a:xfrm>
            <a:off x="855988" y="4574260"/>
            <a:ext cx="8006576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 of KL001 on CREB phosphorylation. B16F10 cells were pretreated with KL001(20 </a:t>
            </a:r>
            <a:r>
              <a:rPr lang="el-GR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) for 2 hours and stimulated with α-MSH (100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M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for 30 minutes in the presence of KL001. The cells were reacted with anti-p-CREB antibody for confocal fluorescence microscopy, displaying the p-CREB-stained with Alexa Fluor 568-labelled secondary antibody as a red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lour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281861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7</TotalTime>
  <Words>305</Words>
  <Application>Microsoft Office PowerPoint</Application>
  <PresentationFormat>全屏显示(4:3)</PresentationFormat>
  <Paragraphs>25</Paragraphs>
  <Slides>4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3</vt:i4>
      </vt:variant>
      <vt:variant>
        <vt:lpstr>幻灯片标题</vt:lpstr>
      </vt:variant>
      <vt:variant>
        <vt:i4>4</vt:i4>
      </vt:variant>
    </vt:vector>
  </HeadingPairs>
  <TitlesOfParts>
    <vt:vector size="13" baseType="lpstr">
      <vt:lpstr>等线</vt:lpstr>
      <vt:lpstr>Arial</vt:lpstr>
      <vt:lpstr>Calibri</vt:lpstr>
      <vt:lpstr>Calibri Light</vt:lpstr>
      <vt:lpstr>Times New Roman</vt:lpstr>
      <vt:lpstr>Office 主题​​</vt:lpstr>
      <vt:lpstr>Prism 5</vt:lpstr>
      <vt:lpstr>Prism 8</vt:lpstr>
      <vt:lpstr>GraphPad Prism 8 Project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cr</dc:creator>
  <cp:lastModifiedBy>wcr</cp:lastModifiedBy>
  <cp:revision>18</cp:revision>
  <dcterms:created xsi:type="dcterms:W3CDTF">2022-06-18T07:48:25Z</dcterms:created>
  <dcterms:modified xsi:type="dcterms:W3CDTF">2022-12-21T16:51:40Z</dcterms:modified>
</cp:coreProperties>
</file>